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EDBA24-6221-F577-ABAB-4CFB9632A4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070DBC-900C-5C1A-9591-5E62FCA07F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3CA6EB-3CA1-AD7F-D42C-8BE6742A2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9CD838-124A-CB06-73F0-218BB28B6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CA0026-23CB-73E8-226F-1C9F8B8CF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975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45F41D-A255-DCB4-3C68-D9DBE13A2C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4BBA99-9B0E-6CB9-44C1-D985797D0F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8C858F-B955-F477-9052-0C6FEC307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D1FD94-8525-321C-BC24-42B60E234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D2268-64D9-473D-F673-6EB2CE5E0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59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F793D1-A870-81A4-1C1B-B365F623DC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6BFAAA-A06E-6AA8-C324-C107BE9F18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78E394-5068-69CE-3865-53FF6C105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2742E0-8CFC-5ED0-B964-99E8B30E6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C96C5-3DA9-093F-A02E-3A3A7C0E7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675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B8A48-07A2-42D7-320E-A69CF145F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B7D9EB-A8CD-17FE-08FE-5D500847CD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D4D1CF-E81A-98A5-0224-272B26FE2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D1B3F8-5289-1490-37FE-BB4CC7D73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F0B7F7-9304-1A12-F188-6B9AF483D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810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1B7C1-F5FA-BEEA-1F82-38D893DF88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57DCA8-A13A-336F-2144-B4A5DCB57C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D91A8F-9D58-0A3C-6FF3-E88BAE37B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12600E-6C22-A696-0E1A-A09C1A2E4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37677-004F-6484-A47D-A9698BF78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5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0D851E-6B9F-395B-F71E-340F791EB9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491517-C597-909B-0118-B264F6B8E7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A9FDFF-9757-EA76-A32E-B73B7DD019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44E8B8-AFF4-F989-602F-433D38B766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6CE0F5-FFB1-0B8F-ADE9-954F7E22F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53E618-B062-680F-D327-1D874ED42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2BAE8-C9AC-A4DF-9E70-4805E7C8A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379B66-E4C0-8DD2-2515-10C2E0280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CE5A00-7E89-E228-2A92-6925951162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85011D-A5D7-D13D-8F45-725F74E66B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04A091-1016-06C6-0E43-F19096A2B5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D03F8B-3CF9-ABA7-3EB6-0D83040F4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7A7AA5-A162-429A-3E69-0DABA11BE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D266E8-A1FC-6FAB-FF94-EBCB803C7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248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82F14D-3D21-B751-761E-488988CABA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85910C-8ECB-14EF-51EC-455F85DB8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1FBA9D-C399-8451-7717-7ACD27E1B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7F15CC-16CD-CFE3-2C39-497D5B4D5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595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1E505E-5115-E61C-30E5-6633E4230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DAFFB2-40B8-3F77-CD63-56482DC89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4E8C76-D057-3E06-D642-4B359CE29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705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CE8D49-224B-48E2-C96E-03F4A580A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C666E6-B5C8-88C3-8F00-66E35F1623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8EB547-76DC-C03B-13E5-C388FC4457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934C30-02B7-2801-5D49-435EDEE62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63DF2B-1A78-CAF2-5300-E94FD14CA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EB5F95-6675-BE44-137D-36F840CBD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641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D1E5D-00CC-35C3-5881-F5E38368CE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A478CF9-BBD6-AD97-AC49-B81F237CC8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7E4B13-8B4D-6E63-754B-903639362F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C76E0-D69D-F90B-2EA1-0E79FF00B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B5A8CD-2813-9208-795D-733CC6BD9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6EF2A2-8AF3-CD38-529B-FC83EE0E4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9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487897-16F7-2CD3-B53E-DF454E93E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AD97DC-FC31-6F07-3213-B829F9404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5BA09D-4D46-A271-8496-4190A4E201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337720-8B38-43E6-BC15-4EEBA6F02E76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70AB13-65D9-F2BE-8938-A150A94473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FAB12E-EADB-DAC7-5FCB-F19874D5AB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715E9-1A84-46D9-911C-0BBCC862D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585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diagram of a graph&#10;&#10;Description automatically generated">
            <a:extLst>
              <a:ext uri="{FF2B5EF4-FFF2-40B4-BE49-F238E27FC236}">
                <a16:creationId xmlns:a16="http://schemas.microsoft.com/office/drawing/2014/main" id="{361AE75F-5AF8-8961-3BD3-E21F372D1CD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537" y="162298"/>
            <a:ext cx="11271478" cy="418706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FCCD09A-3D7B-4A69-C77C-F25C8480C7C5}"/>
              </a:ext>
            </a:extLst>
          </p:cNvPr>
          <p:cNvSpPr txBox="1"/>
          <p:nvPr/>
        </p:nvSpPr>
        <p:spPr>
          <a:xfrm>
            <a:off x="357146" y="4456087"/>
            <a:ext cx="11378317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5. Phenotypic effects of combining ZL-2201 and Doxorubicin</a:t>
            </a:r>
            <a:r>
              <a:rPr lang="en-US" sz="1600" dirty="0"/>
              <a:t>. (A) Cell lines were treated for 6 days with ZL-2201 and doxorubicin at various concentrations for 6 days followed by CTG assay. Synergy score was calculated by </a:t>
            </a:r>
            <a:r>
              <a:rPr lang="en-US" sz="1600" dirty="0" err="1"/>
              <a:t>SynergyFinder</a:t>
            </a:r>
            <a:r>
              <a:rPr lang="en-US" sz="1600" dirty="0"/>
              <a:t> and </a:t>
            </a:r>
            <a:r>
              <a:rPr lang="en-US" sz="1600" dirty="0" err="1"/>
              <a:t>Combenefit</a:t>
            </a:r>
            <a:r>
              <a:rPr lang="en-US" sz="1600" dirty="0"/>
              <a:t>. Synergy score grater than 10 is indicative of strong synergistic activity. (B) Normal and cancer cell lines were treated with a range of ZL-2201 concentrations and 0.001uM doxorubicin. Media was refreshed after 24 hours and CTG assay performed after additional 5 days. Doxorubicin ( 0.001uM) alone did not induce significant cell death. (C) NCI-H1703 cells were treated with a combination of ZL-2201 and doxorubicin at indicated concentrations for 72 hours. Confocal high content analysis of phospho-Histone H3 (Ser10) and cleaved caspase 3(Asp175) was measured using the </a:t>
            </a:r>
            <a:r>
              <a:rPr lang="en-US" sz="1600" dirty="0" err="1"/>
              <a:t>ImageXpress</a:t>
            </a:r>
            <a:r>
              <a:rPr lang="en-US" sz="1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07907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Bhola</dc:creator>
  <cp:lastModifiedBy>Neil Bhola</cp:lastModifiedBy>
  <cp:revision>1</cp:revision>
  <dcterms:created xsi:type="dcterms:W3CDTF">2023-07-28T20:46:09Z</dcterms:created>
  <dcterms:modified xsi:type="dcterms:W3CDTF">2023-07-28T20:46:40Z</dcterms:modified>
</cp:coreProperties>
</file>